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741" autoAdjust="0"/>
    <p:restoredTop sz="96127" autoAdjust="0"/>
  </p:normalViewPr>
  <p:slideViewPr>
    <p:cSldViewPr snapToGrid="0">
      <p:cViewPr varScale="1">
        <p:scale>
          <a:sx n="73" d="100"/>
          <a:sy n="73" d="100"/>
        </p:scale>
        <p:origin x="508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02DCE4-AC42-44B5-8D03-0DE95135CD72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884185-0280-4899-8925-440DE2A3CC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93426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9094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900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0044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7731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0255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9254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613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9784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6551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6716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3526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7589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1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1C4B69FF-D990-3903-5F4F-088DEA59E7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3267050"/>
              </p:ext>
            </p:extLst>
          </p:nvPr>
        </p:nvGraphicFramePr>
        <p:xfrm>
          <a:off x="218425" y="877104"/>
          <a:ext cx="6217099" cy="520838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238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353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353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225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09025">
                <a:tc>
                  <a:txBody>
                    <a:bodyPr/>
                    <a:lstStyle/>
                    <a:p>
                      <a:pPr algn="l" latinLnBrk="1"/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87" marR="91487"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Patients with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CV event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(n = 64)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Patients without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CV event </a:t>
                      </a: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(n = 308)</a:t>
                      </a:r>
                      <a:endParaRPr lang="ko-KR" altLang="ko-KR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P</a:t>
                      </a:r>
                      <a:endParaRPr lang="ko-KR" altLang="ko-KR" sz="1200" b="1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4093">
                <a:tc>
                  <a:txBody>
                    <a:bodyPr/>
                    <a:lstStyle/>
                    <a:p>
                      <a:pPr algn="l" latinLnBrk="1"/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87" marR="91487" marT="45721" marB="4572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20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615" marR="686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 mass index (g/m</a:t>
                      </a:r>
                      <a:r>
                        <a:rPr lang="en-US" altLang="ko-KR" sz="12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.7±31.6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61" marR="5146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.5±36.7</a:t>
                      </a:r>
                      <a:endParaRPr lang="ko-KR" alt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61" marR="5146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895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51461" marR="5146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Ds (mm)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7±6.4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61" marR="5146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7±7.5</a:t>
                      </a:r>
                      <a:endParaRPr lang="ko-KR" alt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61" marR="51461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978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6152780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Dd</a:t>
                      </a: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m)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8±5.6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5±6.6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501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ESV (mL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8±16.8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4±20.3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851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EDV (mL)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8±31.3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8±34.3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380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EF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4±8.1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8±8.2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17</a:t>
                      </a:r>
                      <a:endParaRPr lang="ko-KR" altLang="en-US" sz="1200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ST </a:t>
                      </a: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m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7±3.6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±2.2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186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WT (mm)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±1.9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±2.6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718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3716380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 wave (cm/sec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74.7±28.8</a:t>
                      </a:r>
                      <a:endParaRPr lang="ko-KR" sz="12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83.2±28.1</a:t>
                      </a:r>
                      <a:endParaRPr lang="ko-KR" sz="12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299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wave </a:t>
                      </a: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m/sec)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84.0±30.8</a:t>
                      </a:r>
                      <a:endParaRPr lang="ko-KR" sz="12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78.3±27.7</a:t>
                      </a:r>
                      <a:endParaRPr lang="ko-KR" sz="12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021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1203431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/A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.8±0.3</a:t>
                      </a:r>
                      <a:endParaRPr lang="ko-KR" sz="12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.0±1.0</a:t>
                      </a:r>
                      <a:endParaRPr lang="ko-KR" sz="12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410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2313844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’ (cm/sec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±1.2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±1.8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&lt;0.001</a:t>
                      </a:r>
                      <a:endParaRPr lang="ko-KR" altLang="en-US" sz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/E’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5±6.4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±5.0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9566976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 dimension (mm)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3±7.7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6±6.6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6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0101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 volume index (mL/m</a:t>
                      </a:r>
                      <a:r>
                        <a:rPr lang="en-US" altLang="ko-KR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7±17.8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2±13.5</a:t>
                      </a:r>
                      <a:endParaRPr lang="ko-KR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aseline="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158</a:t>
                      </a:r>
                      <a:endParaRPr lang="ko-KR" altLang="en-US" sz="1200" baseline="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5" name="직사각형 4">
            <a:extLst>
              <a:ext uri="{FF2B5EF4-FFF2-40B4-BE49-F238E27FC236}">
                <a16:creationId xmlns:a16="http://schemas.microsoft.com/office/drawing/2014/main" id="{69B9FEFA-97A8-21ED-9F64-F4EDAAF222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061" y="169163"/>
            <a:ext cx="62154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Supplementary</a:t>
            </a:r>
            <a:r>
              <a:rPr lang="ko-KR" altLang="en-US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Table 2. </a:t>
            </a:r>
            <a:r>
              <a:rPr lang="en-US" altLang="ko-KR" sz="12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Echocardiographic data of the study population</a:t>
            </a:r>
            <a:endParaRPr lang="ko-KR" altLang="ko-KR" sz="12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E5873F1-DE03-A5B4-E43C-0DDB2B46BE0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8425" y="6110034"/>
                <a:ext cx="6217099" cy="17201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algn="just" eaLnBrk="1" hangingPunct="1">
                  <a:lnSpc>
                    <a:spcPct val="150000"/>
                  </a:lnSpc>
                  <a:spcBef>
                    <a:spcPct val="0"/>
                  </a:spcBef>
                  <a:buNone/>
                </a:pPr>
                <a:r>
                  <a:rPr lang="en-US" altLang="ko-KR" sz="12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Echocardiography was examined in 227 (61.0%) patients </a:t>
                </a:r>
              </a:p>
              <a:p>
                <a:pPr algn="just" eaLnBrk="1" hangingPunct="1">
                  <a:lnSpc>
                    <a:spcPct val="150000"/>
                  </a:lnSpc>
                  <a:spcBef>
                    <a:spcPct val="0"/>
                  </a:spcBef>
                  <a:buNone/>
                </a:pPr>
                <a:r>
                  <a:rPr lang="en-US" altLang="ko-KR" sz="12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Data are expressed as mean </a:t>
                </a:r>
                <a14:m>
                  <m:oMath xmlns:m="http://schemas.openxmlformats.org/officeDocument/2006/math">
                    <m:r>
                      <a:rPr lang="en-US" altLang="ko-KR" sz="1200" i="1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±</m:t>
                    </m:r>
                  </m:oMath>
                </a14:m>
                <a:r>
                  <a:rPr lang="en-US" altLang="ko-KR" sz="12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 standard deviation</a:t>
                </a:r>
              </a:p>
              <a:p>
                <a:pPr algn="just" eaLnBrk="1" hangingPunct="1">
                  <a:lnSpc>
                    <a:spcPct val="150000"/>
                  </a:lnSpc>
                  <a:spcBef>
                    <a:spcPct val="0"/>
                  </a:spcBef>
                  <a:buNone/>
                </a:pPr>
                <a:r>
                  <a:rPr lang="en-US" altLang="ko-KR" sz="12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LV, left ventricle; LVDs, left ventricular end-systolic diameter; </a:t>
                </a:r>
                <a:r>
                  <a:rPr lang="en-US" altLang="ko-KR" sz="1200" dirty="0" err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LVDd</a:t>
                </a:r>
                <a:r>
                  <a:rPr lang="en-US" altLang="ko-KR" sz="12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, left ventricular end-diastolic diameter; LVESV, left ventricular end-systolic volume; LVEDV, left ventricular end-diastolic volume; IVST, interventricular septal thickness in diastolic; PWT, LV posterior wall thickness in diastolic; LVEF, left ventricle ejection fraction; LA, left atrium.</a:t>
                </a:r>
              </a:p>
            </p:txBody>
          </p:sp>
        </mc:Choice>
        <mc:Fallback xmlns="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E5873F1-DE03-A5B4-E43C-0DDB2B46BE0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 bwMode="auto">
              <a:xfrm>
                <a:off x="218425" y="6110034"/>
                <a:ext cx="6217099" cy="1720151"/>
              </a:xfrm>
              <a:prstGeom prst="rect">
                <a:avLst/>
              </a:prstGeom>
              <a:blipFill>
                <a:blip r:embed="rId2"/>
                <a:stretch>
                  <a:fillRect l="-98" b="-1773"/>
                </a:stretch>
              </a:blipFill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900473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02</TotalTime>
  <Words>229</Words>
  <Application>Microsoft Office PowerPoint</Application>
  <PresentationFormat>화면 슬라이드 쇼(4:3)</PresentationFormat>
  <Paragraphs>7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Cambria Math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이유호</cp:lastModifiedBy>
  <cp:revision>484</cp:revision>
  <dcterms:created xsi:type="dcterms:W3CDTF">2019-03-14T08:36:26Z</dcterms:created>
  <dcterms:modified xsi:type="dcterms:W3CDTF">2023-12-20T14:24:18Z</dcterms:modified>
</cp:coreProperties>
</file>